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2825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5E047E-49BA-433C-8C29-0566A1290F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343080" y="2189160"/>
            <a:ext cx="616896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343080" y="5762160"/>
            <a:ext cx="616896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8D6395-83F2-45EB-9B2A-4AEF7C8F7B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343080" y="2189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3504240" y="2189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343080" y="5762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3504240" y="5762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C3987-A98D-4083-A28D-9CEAE2A0B3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343080" y="2189160"/>
            <a:ext cx="19861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2428920" y="2189160"/>
            <a:ext cx="19861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4514760" y="2189160"/>
            <a:ext cx="19861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343080" y="5762160"/>
            <a:ext cx="19861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2428920" y="5762160"/>
            <a:ext cx="19861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4514760" y="5762160"/>
            <a:ext cx="19861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EBC9F-5CFC-468B-8073-9CDC4A644E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343080" y="2189160"/>
            <a:ext cx="6168960" cy="684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C2B91-2A59-4365-B70A-0707A1A15A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343080" y="2189160"/>
            <a:ext cx="6168960" cy="68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28F7D5-813C-4957-B55B-594C8D92E0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343080" y="2189160"/>
            <a:ext cx="3010320" cy="68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3504240" y="2189160"/>
            <a:ext cx="3010320" cy="68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11161B-2B7C-4630-B68E-1A2C1BB006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DAE07A-FB9C-43BE-98FE-76BFE683E2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343080" y="877680"/>
            <a:ext cx="6168960" cy="4341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0F4548-3A49-4BEF-AFB0-1532A3A7E3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343080" y="2189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3504240" y="2189160"/>
            <a:ext cx="3010320" cy="68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343080" y="5762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64EBBA-033E-44C8-B3BF-F82272FCED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343080" y="2189160"/>
            <a:ext cx="3010320" cy="68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3504240" y="2189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3504240" y="5762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B34C5-EFD3-4E76-9520-1F3468F74A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343080" y="2189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3504240" y="2189160"/>
            <a:ext cx="301032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343080" y="5762160"/>
            <a:ext cx="6168960" cy="326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9BB04-D373-40F2-A477-3A0A206D78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877680"/>
            <a:ext cx="6168960" cy="936360"/>
          </a:xfrm>
          <a:prstGeom prst="rect">
            <a:avLst/>
          </a:prstGeom>
          <a:noFill/>
          <a:ln w="0">
            <a:noFill/>
          </a:ln>
        </p:spPr>
        <p:txBody>
          <a:bodyPr lIns="101520" rIns="76320" tIns="38160" bIns="3816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27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27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89160"/>
            <a:ext cx="6168960" cy="68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  <a:p>
            <a:pPr lvl="1" marL="514440" indent="-17136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  <a:p>
            <a:pPr lvl="2" marL="857160" indent="-17136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  <a:p>
            <a:pPr lvl="3" marL="1200240" indent="-17136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  <a:p>
            <a:pPr lvl="4" marL="1542960" indent="-17136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  <a:p>
            <a:pPr lvl="5" marL="1542960" indent="-17136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  <a:p>
            <a:pPr lvl="6" marL="1542960" indent="-17136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2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4520" y="9118440"/>
            <a:ext cx="15192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7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7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14440" y="9118440"/>
            <a:ext cx="2229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94280" y="9118440"/>
            <a:ext cx="1517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7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F05AF7-36E8-410C-8496-95D3FAD7E064}" type="slidenum">
              <a:rPr b="0" lang="en-US" sz="7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KSO_TEMPLATE" hidden="1"/>
          <p:cNvSpPr/>
          <p:nvPr/>
        </p:nvSpPr>
        <p:spPr>
          <a:xfrm>
            <a:off x="0" y="0"/>
            <a:ext cx="360" cy="360"/>
          </a:xfrm>
          <a:prstGeom prst="rect">
            <a:avLst/>
          </a:prstGeom>
          <a:solidFill>
            <a:srgbClr val="6096e6"/>
          </a:solidFill>
          <a:ln w="12600">
            <a:solidFill>
              <a:srgbClr val="446da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图片 1" descr=""/>
          <p:cNvPicPr/>
          <p:nvPr/>
        </p:nvPicPr>
        <p:blipFill>
          <a:blip r:embed="rId1"/>
          <a:stretch/>
        </p:blipFill>
        <p:spPr>
          <a:xfrm>
            <a:off x="701640" y="530280"/>
            <a:ext cx="5059440" cy="4721040"/>
          </a:xfrm>
          <a:prstGeom prst="rect">
            <a:avLst/>
          </a:prstGeom>
          <a:ln w="0">
            <a:noFill/>
          </a:ln>
        </p:spPr>
      </p:pic>
      <p:sp>
        <p:nvSpPr>
          <p:cNvPr id="43" name="文本框 1"/>
          <p:cNvSpPr/>
          <p:nvPr/>
        </p:nvSpPr>
        <p:spPr>
          <a:xfrm>
            <a:off x="701640" y="5460840"/>
            <a:ext cx="5423040" cy="237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ts val="1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Supplementary Fig 1.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Shannon analysis of 16S rRNA gene sequencing results from gut microbiota of siblings of WT and </a:t>
            </a:r>
            <a:r>
              <a:rPr b="1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Dock2</a:t>
            </a:r>
            <a:r>
              <a:rPr b="1" i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-/-</a:t>
            </a:r>
            <a:r>
              <a:rPr b="1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mice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.</a:t>
            </a:r>
            <a:r>
              <a:rPr b="0" lang="en-US" sz="1400" spc="-1" strike="noStrike">
                <a:solidFill>
                  <a:srgbClr val="000000"/>
                </a:solidFill>
                <a:latin typeface="等线"/>
                <a:ea typeface="等线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Shannon index in alpha diversity analysis of microbial community was shown. A represented the siblings of WT mice before cage division, B represented the siblings of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Dock2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-/-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mice before cage division, C represented siblings of WT mice at 6 weeks after cage division, and D represented the siblings of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Dock2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-/-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mice at 6 weeks after cage division.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图片 1" descr=""/>
          <p:cNvPicPr/>
          <p:nvPr/>
        </p:nvPicPr>
        <p:blipFill>
          <a:blip r:embed="rId1"/>
          <a:stretch/>
        </p:blipFill>
        <p:spPr>
          <a:xfrm>
            <a:off x="792000" y="515880"/>
            <a:ext cx="5274000" cy="4908600"/>
          </a:xfrm>
          <a:prstGeom prst="rect">
            <a:avLst/>
          </a:prstGeom>
          <a:ln w="0">
            <a:noFill/>
          </a:ln>
        </p:spPr>
      </p:pic>
      <p:sp>
        <p:nvSpPr>
          <p:cNvPr id="45" name="文本框 1"/>
          <p:cNvSpPr/>
          <p:nvPr/>
        </p:nvSpPr>
        <p:spPr>
          <a:xfrm>
            <a:off x="792000" y="5799240"/>
            <a:ext cx="538344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Supplementary Fig 2.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Shannon analysis of 16S rRNA gene Sequencing results from WT and </a:t>
            </a:r>
            <a:r>
              <a:rPr b="1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Dock2</a:t>
            </a:r>
            <a:r>
              <a:rPr b="1" i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-/-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mouse gut microbiota before and after cohousing.</a:t>
            </a:r>
            <a:r>
              <a:rPr b="0" lang="en-US" sz="1400" spc="-1" strike="noStrike">
                <a:solidFill>
                  <a:srgbClr val="000000"/>
                </a:solidFill>
                <a:latin typeface="等线"/>
                <a:ea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Shannon index in alpha diversity analysis of microbial community was shown. CB-W represented WT mice before cohousing, CB-K represented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Dock2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-/-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mice before cohousing, CA-W represented WT mice at 4 weeks after cohousing, and CA-K represented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Dock2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-/-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mice after cohousing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文本框 3"/>
          <p:cNvSpPr/>
          <p:nvPr/>
        </p:nvSpPr>
        <p:spPr>
          <a:xfrm>
            <a:off x="730080" y="18108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文本框 5"/>
          <p:cNvSpPr/>
          <p:nvPr/>
        </p:nvSpPr>
        <p:spPr>
          <a:xfrm>
            <a:off x="730080" y="3549600"/>
            <a:ext cx="85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图片 1" descr=""/>
          <p:cNvPicPr/>
          <p:nvPr/>
        </p:nvPicPr>
        <p:blipFill>
          <a:blip r:embed="rId1"/>
          <a:stretch/>
        </p:blipFill>
        <p:spPr>
          <a:xfrm>
            <a:off x="1303200" y="136440"/>
            <a:ext cx="3484800" cy="3238560"/>
          </a:xfrm>
          <a:prstGeom prst="rect">
            <a:avLst/>
          </a:prstGeom>
          <a:ln w="0">
            <a:noFill/>
          </a:ln>
        </p:spPr>
      </p:pic>
      <p:pic>
        <p:nvPicPr>
          <p:cNvPr id="49" name="图片 2" descr=""/>
          <p:cNvPicPr/>
          <p:nvPr/>
        </p:nvPicPr>
        <p:blipFill>
          <a:blip r:embed="rId2"/>
          <a:stretch/>
        </p:blipFill>
        <p:spPr>
          <a:xfrm>
            <a:off x="1303200" y="3666960"/>
            <a:ext cx="3484800" cy="3256200"/>
          </a:xfrm>
          <a:prstGeom prst="rect">
            <a:avLst/>
          </a:prstGeom>
          <a:ln w="0">
            <a:noFill/>
          </a:ln>
        </p:spPr>
      </p:pic>
      <p:sp>
        <p:nvSpPr>
          <p:cNvPr id="50" name="文本框 3"/>
          <p:cNvSpPr/>
          <p:nvPr/>
        </p:nvSpPr>
        <p:spPr>
          <a:xfrm>
            <a:off x="206280" y="6823080"/>
            <a:ext cx="6445440" cy="283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Supplementary Fig 3.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chao1 analysis of 16S rRNA Sequencing results from WT and </a:t>
            </a:r>
            <a:r>
              <a:rPr b="1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Dock2</a:t>
            </a:r>
            <a:r>
              <a:rPr b="1" i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-/-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gut microbiota before and after transfer to WT mice.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Chao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index in alpha diversity analysis of microbial community was shown. AB represented mice before streptomycin treatment; FB-W represented WT mice before transfer, after which they were transferred with WT gut microbiota; FB-K represented for WT mice before transfer, after which they were transferred with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Dock2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-/-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mouse gut microbiota. FA-W represented WT mice which received WT mouse microbiota; FA-K represented WT mice which received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Dock2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-/-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 mouse microbiota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9T02:08:00Z</dcterms:created>
  <dc:creator/>
  <dc:description/>
  <dc:language>en-US</dc:language>
  <cp:lastModifiedBy>Z L</cp:lastModifiedBy>
  <cp:lastPrinted>2021-06-17T07:17:22Z</cp:lastPrinted>
  <dcterms:modified xsi:type="dcterms:W3CDTF">2021-08-02T14:25:36Z</dcterms:modified>
  <cp:revision>176</cp:revision>
  <dc:subject/>
  <dc:title>空白演示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58B3908124D4095B80DAAF8D57F5144</vt:lpwstr>
  </property>
  <property fmtid="{D5CDD505-2E9C-101B-9397-08002B2CF9AE}" pid="3" name="KSOProductBuildVer">
    <vt:lpwstr>2052-11.1.0.10463</vt:lpwstr>
  </property>
</Properties>
</file>